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72" userDrawn="1">
          <p15:clr>
            <a:srgbClr val="A4A3A4"/>
          </p15:clr>
        </p15:guide>
        <p15:guide id="2" pos="48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792" y="60"/>
      </p:cViewPr>
      <p:guideLst>
        <p:guide orient="horz" pos="3672"/>
        <p:guide pos="48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190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973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100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979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32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933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17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846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065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44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301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653EB-751E-44CB-BEF1-6BDA63B5E85D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69A6FD-1F88-4314-B461-C727376475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006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00088" y="5509264"/>
            <a:ext cx="10972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Fig.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-cell epitope prediction of Sensor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stidin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rotein kinas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hpB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: Linear, B: Beta-turn, C: Flexibility, D: Surface Accessibility, E: Antigenicity, F: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ydrophilicity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For each graph, X-axis and Y-axis represent the position and score. Residues that fall above the threshold value are shown in yellow color while the highest peak in yellow color identifies most favored position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C:\Users\User\Desktop\Hasan_Vibrio\fwdallfiguresmahmudulhasan\Supplementary Figure 1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6174" y="0"/>
            <a:ext cx="6099175" cy="550926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54788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</TotalTime>
  <Words>7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athish</cp:lastModifiedBy>
  <cp:revision>18</cp:revision>
  <dcterms:created xsi:type="dcterms:W3CDTF">2020-03-31T14:28:06Z</dcterms:created>
  <dcterms:modified xsi:type="dcterms:W3CDTF">2020-07-30T10:12:49Z</dcterms:modified>
</cp:coreProperties>
</file>